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120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F7F22C7-D764-9CFC-B8E9-D0FFE039D9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D1F82955-211F-DBEB-DE98-79EA6373BD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4079098-B5B3-64DF-4B7F-17249D614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46D3CD9-2045-BA63-376D-A27BBE424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5A2BA60-50BA-6171-B5D6-08B3ECABA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98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922C0085-5D4D-C87D-2CD8-9EC9825CA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9B7AFA1-C75B-CC04-CF6C-4AE49A770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9D68A8C-C262-6111-D40C-81CEEFCA9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843284B-584A-199E-7E6D-2663D97E8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77C422A-38BB-AC47-AAB6-3E2C1B2F1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8546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ABCAA2E3-BD91-7BDD-3D66-2627B99185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3155CA18-7B77-BB7E-995B-8077DFC849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E6AE9DA-180E-1EC6-DE0D-253CBEDD7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FE46FC5-14BD-D879-6EE4-5ECC37415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6D122B9-C35C-F86B-9B09-8E3AA21FC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212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A48615B-B12E-E18F-F36A-415029DADF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925FC521-A007-83FD-DEA8-D8BCC65BF1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BD46449D-E42A-981B-0F80-94D3BA0AEC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812BE37-AC5C-55C0-E8AF-7CA41CE3C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888F57A-5B8B-8228-8794-038484386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3316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BE9BF15-0B6A-FA69-4870-C62354F35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6BE8B6F3-7C67-6080-24CE-A3DFBCC2D9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7FCA767-B90A-B3C8-BE5C-81FD619FB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9F7E79E-076A-BC1D-CD69-16D12ADD8F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D436A1B-7CB0-58D3-1E52-45684E333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4702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F5383CD-C392-FEFB-83E1-6E7C9AB147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54A3A22-52B8-624A-7A5A-72F87AEC83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B2160B43-6946-B5D9-AEE4-1C44E7C0C5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8ECEB65-F6A5-9718-CC5F-C277B270F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F2D76552-A9BC-78B4-49BE-7B12FF6BA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442AAA6-3B1C-3339-4638-3F15CB51B3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3280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ECB4FCB-352E-5B75-6A1B-AAFE08D06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7F896B0-73A5-8A62-DA9E-F11DB9483B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9A07BD90-46C1-8E30-927D-8CBBFBD16E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DD392130-E91C-3314-3C7C-C0A7685723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50780A35-1B23-C02A-F36B-BB23321A3F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50341BE3-B4E6-4AD6-2816-4B2FC0A2E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09A73429-8093-1DAE-CF02-F669589D8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078FA99A-B3B4-D033-7F36-6888621C6B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37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F4A9CC9-1664-24F1-9388-9692126C98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7B29B440-A427-18BA-372B-1401F9C10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941079CC-E844-D11A-C051-7DA20EF3A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78D90281-B9B4-654C-0B64-EAE156D25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5415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B52E5EBA-282F-F48D-1646-00761AF8C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B35E5E57-9CA1-873C-B128-449DAF610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1CFCA9E3-256F-778F-0160-6BF24D725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939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63F6DAD-388D-69A0-C2AE-41953D3153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40667F8-81E4-731F-E402-0FFF694449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E6F2BE37-9328-6314-8950-C31888756D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5E6C3FE-08E0-6961-D4BB-0F55C32C2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77B46E8-2D57-F04E-A82C-80334E845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B72F8FA-AA6F-F826-A878-848EBACFD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4367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AA3203D-48C8-C27A-FB1E-48A51A71A2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CF3E350E-ED38-0DB9-4B0E-399D938B57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C9DF78F-32C8-3DB1-9DB7-1A51D8202B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B713AB8-083A-900E-8316-07E9EDE29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14EF183-915F-0874-3F84-54E809880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3EB1CB06-DC77-1824-F030-7C3763323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292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9D7F0DF-10D1-ADF8-1692-8B563CBDC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6C3601-464E-21FB-F78A-73FAE3E9CB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B69F379A-3ED2-CF24-40A1-DC6D22F0DE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6038-EB99-466F-97EB-6C76E6114EEB}" type="datetimeFigureOut">
              <a:rPr lang="zh-CN" altLang="en-US" smtClean="0"/>
              <a:t>2023/9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C55A103-C32B-C5AA-571A-B6A9D861EA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7564B16-5382-8C00-7FFE-5B5F0C3D70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F1313-014E-4D9D-8314-0E8C7CAFAFD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5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1B228A3E-8644-BD83-3E71-DB3F54E15E4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1051" y="1596136"/>
            <a:ext cx="4468573" cy="299618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C5E37DC4-5CC9-30BF-9F6A-891B520BF2EF}"/>
              </a:ext>
            </a:extLst>
          </p:cNvPr>
          <p:cNvSpPr txBox="1"/>
          <p:nvPr/>
        </p:nvSpPr>
        <p:spPr>
          <a:xfrm>
            <a:off x="-1712" y="462605"/>
            <a:ext cx="60977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ffect of CSO on viability of TNF-α induced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LS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F8E6CB60-A64B-4FA4-39DC-C7ABEB600082}"/>
              </a:ext>
            </a:extLst>
          </p:cNvPr>
          <p:cNvSpPr txBox="1"/>
          <p:nvPr/>
        </p:nvSpPr>
        <p:spPr>
          <a:xfrm>
            <a:off x="0" y="4966638"/>
            <a:ext cx="1224115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 file 1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CSO on viability of TNF-α induced FLS.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S viability (%), n = 6.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4194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等线</vt:lpstr>
      <vt:lpstr>等线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强 强</dc:creator>
  <cp:lastModifiedBy>Chandravadhana Ramesh</cp:lastModifiedBy>
  <cp:revision>3</cp:revision>
  <dcterms:created xsi:type="dcterms:W3CDTF">2023-08-25T12:28:17Z</dcterms:created>
  <dcterms:modified xsi:type="dcterms:W3CDTF">2023-09-07T07:21:41Z</dcterms:modified>
</cp:coreProperties>
</file>